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2" autoAdjust="0"/>
    <p:restoredTop sz="94660"/>
  </p:normalViewPr>
  <p:slideViewPr>
    <p:cSldViewPr snapToGrid="0">
      <p:cViewPr varScale="1">
        <p:scale>
          <a:sx n="66" d="100"/>
          <a:sy n="66" d="100"/>
        </p:scale>
        <p:origin x="7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AD546-E246-1244-792A-67B32169BC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2C7CEB-4F6A-86F4-7BC0-88EB7AE662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2CD00-DB00-54EE-8E87-480B5EC03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DC0667-A64D-3949-3574-7A3B2716C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E9C44D-FC86-F123-AEC8-314D20947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165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84B8D-6020-0CEA-7BA1-0B0D8C9E23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7A5F6B-8A4D-4F19-CA2D-E4C5AD29A0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FCBAF9-37DB-04CB-7E20-E7DEDB0322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13A19A-8B83-0800-D0C6-E5F07BF2B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5B3336-B65F-E6E6-6E1F-C29E4FFD2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910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64E5E5-91B0-27E5-F028-91C8A7CC5F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8EC5B8-AC1B-DAB9-80FB-21E491FC34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26ACA3-29D2-575B-00D1-96C187B44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B6C9ED-F02D-8710-53FE-0BBE5EF8CA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6229D8-369A-D5F6-05A9-FD5F15E7F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646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81E0B-A74D-A394-0B80-9B6299EDBF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19154F-A759-5A4C-65D0-86CFDDCF57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1AE7AA-AF80-E202-6A35-957A11D5E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A703C-3A4C-625D-BB02-B66173B21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49135-CEFF-1701-1A74-C2444E844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564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BFBA6B-F955-C03E-672F-61C6EFAD2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55BB10-80D4-DE82-0FED-AAE7906FEF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D02C50-D979-3E91-1233-E4551D35E4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A9F65E-21BB-85F8-4B0B-C6AADBAD3B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028B5-E9A0-96E1-BD2F-A33B32635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780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D62A26-CB2E-4C22-85A3-3BCE2F44C9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151E32-8B6A-A816-EE57-581FF1D4F8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9AA273-7CF1-BE5F-9F54-D4D431FEF0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3FF790-AA3E-5BF9-5604-F99C1D168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95A08C-60AB-A54B-FD06-355339610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93723B-FEE4-1646-BF80-353609E3DF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693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9CC244-B7C6-25E4-DFC6-2449548266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C7219B-2F1F-B1FD-398D-30F7712FBE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C8FA0D-6415-58AB-9FF9-00AB656046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C2AE25-4D3C-3AC2-8EDC-42E34B56F8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A10FD2-0056-815B-3C00-6BBDEE8B58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901DD2-0E50-D1D6-B970-2B7833278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D31C203-7A87-1319-6EDE-63D114E42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42D7E29-9E76-0AAE-D16E-B3D7CC584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076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09803-0C55-6024-A31C-E156FFF362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81BA81-F7CC-6E99-1606-8569BAF69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2C0279-1E6E-3EED-A8BF-4E5F93246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E07F1D-896B-9289-68DA-0B3D3F82C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408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A50821-F67F-3EC7-873D-B8F5F2768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2F15163-836C-C349-5408-25190442F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31E717-DCA4-38F5-59A3-7D0538438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10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7315F-4BB4-8E6C-5C00-C858E318D3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D48C7-95A8-0E2C-B1EC-C4D2345C29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2D5E1F-A200-5D9A-2E74-5C7A11FF1A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27444A-52CB-5374-7422-EEFFA6E68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ADAAA1-36E0-D576-8B25-99743A8E8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CF5D47-5908-E397-791E-0122ACB6B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037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E2824-8150-F81D-5E04-133F3097B1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D1F59C-AF03-CC6E-BD4E-01A7C1D818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35B72B-C77F-FA21-D4A6-2EC171025E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9772D9-6EE8-D2E7-B98F-F4FE9C608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4D072D-3DE6-6612-2403-D218F11F6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750AC2-40EA-F78D-3BDA-D5CB54DF0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748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4F2CBBB-23A8-7A36-0881-785586D758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972E65-AD03-2422-33A9-A7A187B96A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F857CE-D5D9-8CA4-39A0-4FA0D2898C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E02913-E536-487C-BF8E-9E34430EA4C9}" type="datetimeFigureOut">
              <a:rPr lang="en-US" smtClean="0"/>
              <a:t>11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093314-61FA-B635-92B6-2E14C63A03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09C987-28D6-05B1-7EAB-2D5CC6DE0A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CC186B-0F2A-416E-8E50-CD722E54B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920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AFD2FE9-9171-90B5-C669-8E1E3D33AA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19040" y="827314"/>
            <a:ext cx="6139124" cy="461331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05F2C77-CC99-E85B-D323-8110AD9FCA98}"/>
              </a:ext>
            </a:extLst>
          </p:cNvPr>
          <p:cNvSpPr txBox="1"/>
          <p:nvPr/>
        </p:nvSpPr>
        <p:spPr>
          <a:xfrm>
            <a:off x="608924" y="5635776"/>
            <a:ext cx="10974150" cy="878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gure S1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sections of normal control group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f the 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liminary study (PSNC). 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23090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85305EA-E5EE-75A2-1AB1-FDCD0D47C1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37551" y="705469"/>
            <a:ext cx="6185419" cy="477638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9F9210C-947F-B8AA-3D9F-964DEBB4F125}"/>
              </a:ext>
            </a:extLst>
          </p:cNvPr>
          <p:cNvSpPr txBox="1"/>
          <p:nvPr/>
        </p:nvSpPr>
        <p:spPr>
          <a:xfrm>
            <a:off x="644367" y="5783346"/>
            <a:ext cx="11193214" cy="878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gure S10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sections showing the 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fect of ferulic acid lipid nano-capsules 25 mg/kg/day (FA-LNCs25 group) of the main study. 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4103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0FB4401-E308-A7F8-701A-DE7B7DBB0D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21546" y="856343"/>
            <a:ext cx="5983097" cy="451571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4E215AE-06A4-F23F-510B-68A958E94886}"/>
              </a:ext>
            </a:extLst>
          </p:cNvPr>
          <p:cNvSpPr txBox="1"/>
          <p:nvPr/>
        </p:nvSpPr>
        <p:spPr>
          <a:xfrm>
            <a:off x="393405" y="5722664"/>
            <a:ext cx="1140519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gure S2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sections of d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abetic rats of the 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liminary study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acrificed after 4 weeks (PS4)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81188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AD9C259-5E26-9BB4-C3DC-B9227C264E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99755" y="653143"/>
            <a:ext cx="6271575" cy="481094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9E2D305-104A-285E-879D-7D0AFB119997}"/>
              </a:ext>
            </a:extLst>
          </p:cNvPr>
          <p:cNvSpPr txBox="1"/>
          <p:nvPr/>
        </p:nvSpPr>
        <p:spPr>
          <a:xfrm>
            <a:off x="450112" y="5722664"/>
            <a:ext cx="1140519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gure S3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sections of d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abetic rats of the 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liminary study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acrificed after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eeks group (P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6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82630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92FF238-3DEA-917D-D610-90A48CA2D7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65193" y="827315"/>
            <a:ext cx="5895392" cy="455864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4C3CB8D-F82E-4224-0C8B-69CB312A54A5}"/>
              </a:ext>
            </a:extLst>
          </p:cNvPr>
          <p:cNvSpPr txBox="1"/>
          <p:nvPr/>
        </p:nvSpPr>
        <p:spPr>
          <a:xfrm>
            <a:off x="393404" y="5807725"/>
            <a:ext cx="1140519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gure S4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sections of d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abetic rats of the 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liminary study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acrificed after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8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eeks group (PS8) 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1405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0E5C72A-DCBD-F526-AF8D-8F3A11D476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09249" y="667658"/>
            <a:ext cx="6256290" cy="483977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7D8FD1E-C35E-C0E7-FC8C-62B3E8F70BAE}"/>
              </a:ext>
            </a:extLst>
          </p:cNvPr>
          <p:cNvSpPr txBox="1"/>
          <p:nvPr/>
        </p:nvSpPr>
        <p:spPr>
          <a:xfrm>
            <a:off x="393404" y="5807725"/>
            <a:ext cx="1140519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gure S5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</a:t>
            </a: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ections of d</a:t>
            </a:r>
            <a:r>
              <a:rPr lang="en-US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abetic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ats of the p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liminary study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acrificed after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eeks group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P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4209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ADF2344-05C8-39A0-6DD8-34E615F9E5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74839" y="725714"/>
            <a:ext cx="6222431" cy="480425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1A1B9A3-4CBE-06B0-4B60-3A467DF8957B}"/>
              </a:ext>
            </a:extLst>
          </p:cNvPr>
          <p:cNvSpPr txBox="1"/>
          <p:nvPr/>
        </p:nvSpPr>
        <p:spPr>
          <a:xfrm>
            <a:off x="601837" y="5776258"/>
            <a:ext cx="11193214" cy="878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gure S</a:t>
            </a:r>
            <a:r>
              <a:rPr lang="ar-EG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+mj-cs"/>
              </a:rPr>
              <a:t>6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sections of Normal (N) group of the main study. 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2622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8C3071D4-CF79-401E-45D7-1B36EA0655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21789" y="654828"/>
            <a:ext cx="6373754" cy="491225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1EDBDCB-3199-8E4D-5151-6DC0785D0855}"/>
              </a:ext>
            </a:extLst>
          </p:cNvPr>
          <p:cNvSpPr txBox="1"/>
          <p:nvPr/>
        </p:nvSpPr>
        <p:spPr>
          <a:xfrm>
            <a:off x="644367" y="5783346"/>
            <a:ext cx="11193214" cy="878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+mj-cs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+mj-cs"/>
              </a:rPr>
              <a:t>igure S</a:t>
            </a:r>
            <a:r>
              <a:rPr lang="ar-EG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+mj-cs"/>
              </a:rPr>
              <a:t>7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+mj-cs"/>
              </a:rPr>
              <a:t>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sections of diabetic nephropathy (DN) control group of the main study. 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06307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337ECC8-B6ED-3D12-8769-197CDFFABE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33487" y="798286"/>
            <a:ext cx="6497300" cy="497630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75D883D-C83E-4AD5-9163-DBB2DB1230D1}"/>
              </a:ext>
            </a:extLst>
          </p:cNvPr>
          <p:cNvSpPr txBox="1"/>
          <p:nvPr/>
        </p:nvSpPr>
        <p:spPr>
          <a:xfrm>
            <a:off x="644367" y="5783346"/>
            <a:ext cx="11193214" cy="878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gure S8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sections showing the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fect of ferulic acid 25 mg/kg/day (FA25 group) of the main study. 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24923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E8EF110-4E66-0C25-EDDF-695815469A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20571" y="868303"/>
            <a:ext cx="6342743" cy="482338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5E80C94-3A1F-F4F7-C77B-AE328B91A1AF}"/>
              </a:ext>
            </a:extLst>
          </p:cNvPr>
          <p:cNvSpPr txBox="1"/>
          <p:nvPr/>
        </p:nvSpPr>
        <p:spPr>
          <a:xfrm>
            <a:off x="644367" y="5783346"/>
            <a:ext cx="11193214" cy="8735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gure S9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croscopic images of H&amp;E-stained renal cortical sections showing the 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fect of ferulic acid 50 mg/kg/day (FA50 group) of the main study.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: 100 bar 100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3120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342</Words>
  <Application>Microsoft Office PowerPoint</Application>
  <PresentationFormat>Widescreen</PresentationFormat>
  <Paragraphs>10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na H. Zohny</dc:creator>
  <cp:lastModifiedBy>Mamdouh M. Shishtawy</cp:lastModifiedBy>
  <cp:revision>35</cp:revision>
  <dcterms:created xsi:type="dcterms:W3CDTF">2024-11-09T16:44:55Z</dcterms:created>
  <dcterms:modified xsi:type="dcterms:W3CDTF">2024-11-15T18:38:15Z</dcterms:modified>
</cp:coreProperties>
</file>